
<file path=[Content_Types].xml><?xml version="1.0" encoding="utf-8"?>
<Types xmlns="http://schemas.openxmlformats.org/package/2006/content-types">
  <Default Extension="rels" ContentType="application/vnd.openxmlformats-package.relationships+xml"/>
  <Default Extension="ti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69" r:id="rId2"/>
    <p:sldId id="268" r:id="rId3"/>
  </p:sldIdLst>
  <p:sldSz cx="9906000" cy="6858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96" userDrawn="1">
          <p15:clr>
            <a:srgbClr val="A4A3A4"/>
          </p15:clr>
        </p15:guide>
        <p15:guide id="3" orient="horz" pos="1139" userDrawn="1">
          <p15:clr>
            <a:srgbClr val="A4A3A4"/>
          </p15:clr>
        </p15:guide>
        <p15:guide id="4" pos="312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8997" autoAdjust="0"/>
    <p:restoredTop sz="94660"/>
  </p:normalViewPr>
  <p:slideViewPr>
    <p:cSldViewPr snapToGrid="0" showGuides="1">
      <p:cViewPr varScale="1">
        <p:scale>
          <a:sx n="128" d="100"/>
          <a:sy n="128" d="100"/>
        </p:scale>
        <p:origin x="1184" y="176"/>
      </p:cViewPr>
      <p:guideLst>
        <p:guide orient="horz" pos="96"/>
        <p:guide orient="horz" pos="1139"/>
        <p:guide pos="312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742950" y="1122363"/>
            <a:ext cx="84201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238250" y="3602038"/>
            <a:ext cx="74295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B2EEEF-EF7F-4E30-A7F2-B73EE9033CDC}" type="datetimeFigureOut">
              <a:rPr lang="en-GB" smtClean="0"/>
              <a:pPr/>
              <a:t>23/05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3EBA9E-1463-4031-8699-28AC8BC29174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45383878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B2EEEF-EF7F-4E30-A7F2-B73EE9033CDC}" type="datetimeFigureOut">
              <a:rPr lang="en-GB" smtClean="0"/>
              <a:pPr/>
              <a:t>23/05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3EBA9E-1463-4031-8699-28AC8BC29174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77262224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7088982" y="365125"/>
            <a:ext cx="2135981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81038" y="365125"/>
            <a:ext cx="6284119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B2EEEF-EF7F-4E30-A7F2-B73EE9033CDC}" type="datetimeFigureOut">
              <a:rPr lang="en-GB" smtClean="0"/>
              <a:pPr/>
              <a:t>23/05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3EBA9E-1463-4031-8699-28AC8BC29174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3353571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B2EEEF-EF7F-4E30-A7F2-B73EE9033CDC}" type="datetimeFigureOut">
              <a:rPr lang="en-GB" smtClean="0"/>
              <a:pPr/>
              <a:t>23/05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3EBA9E-1463-4031-8699-28AC8BC29174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50878712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75879" y="1709740"/>
            <a:ext cx="8543925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75879" y="4589465"/>
            <a:ext cx="8543925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B2EEEF-EF7F-4E30-A7F2-B73EE9033CDC}" type="datetimeFigureOut">
              <a:rPr lang="en-GB" smtClean="0"/>
              <a:pPr/>
              <a:t>23/05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3EBA9E-1463-4031-8699-28AC8BC29174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2057410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81038" y="1825625"/>
            <a:ext cx="421005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014913" y="1825625"/>
            <a:ext cx="421005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B2EEEF-EF7F-4E30-A7F2-B73EE9033CDC}" type="datetimeFigureOut">
              <a:rPr lang="en-GB" smtClean="0"/>
              <a:pPr/>
              <a:t>23/05/2019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3EBA9E-1463-4031-8699-28AC8BC29174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46009316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365127"/>
            <a:ext cx="8543925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2329" y="1681163"/>
            <a:ext cx="4190702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82329" y="2505075"/>
            <a:ext cx="4190702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5014913" y="1681163"/>
            <a:ext cx="4211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5014913" y="2505075"/>
            <a:ext cx="4211340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B2EEEF-EF7F-4E30-A7F2-B73EE9033CDC}" type="datetimeFigureOut">
              <a:rPr lang="en-GB" smtClean="0"/>
              <a:pPr/>
              <a:t>23/05/2019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3EBA9E-1463-4031-8699-28AC8BC29174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41586996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B2EEEF-EF7F-4E30-A7F2-B73EE9033CDC}" type="datetimeFigureOut">
              <a:rPr lang="en-GB" smtClean="0"/>
              <a:pPr/>
              <a:t>23/05/2019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3EBA9E-1463-4031-8699-28AC8BC29174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5757395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B2EEEF-EF7F-4E30-A7F2-B73EE9033CDC}" type="datetimeFigureOut">
              <a:rPr lang="en-GB" smtClean="0"/>
              <a:pPr/>
              <a:t>23/05/2019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3EBA9E-1463-4031-8699-28AC8BC29174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8844643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3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211340" y="987427"/>
            <a:ext cx="5014913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3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B2EEEF-EF7F-4E30-A7F2-B73EE9033CDC}" type="datetimeFigureOut">
              <a:rPr lang="en-GB" smtClean="0"/>
              <a:pPr/>
              <a:t>23/05/2019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3EBA9E-1463-4031-8699-28AC8BC29174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22469713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3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4211340" y="987427"/>
            <a:ext cx="5014913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/>
              <a:t>Click icon </a:t>
            </a:r>
            <a:r>
              <a:rPr lang="en-US" dirty="0"/>
              <a:t>to add picture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3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B2EEEF-EF7F-4E30-A7F2-B73EE9033CDC}" type="datetimeFigureOut">
              <a:rPr lang="en-GB" smtClean="0"/>
              <a:pPr/>
              <a:t>23/05/2019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3EBA9E-1463-4031-8699-28AC8BC29174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7627443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81038" y="365127"/>
            <a:ext cx="8543925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1038" y="1825625"/>
            <a:ext cx="8543925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81038" y="6356352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AB2EEEF-EF7F-4E30-A7F2-B73EE9033CDC}" type="datetimeFigureOut">
              <a:rPr lang="en-GB" smtClean="0"/>
              <a:pPr/>
              <a:t>23/05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281363" y="6356352"/>
            <a:ext cx="3343275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996113" y="6356352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63EBA9E-1463-4031-8699-28AC8BC29174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9394363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1141759" y="227358"/>
            <a:ext cx="7838624" cy="147732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/>
              <a:t>Supplementary Figure S3</a:t>
            </a:r>
            <a:r>
              <a:rPr lang="en-GB" dirty="0"/>
              <a:t>. Count distributions derived from the root transcriptomes.  DESeq2 </a:t>
            </a:r>
            <a:r>
              <a:rPr lang="en-GB" dirty="0" err="1"/>
              <a:t>rlog</a:t>
            </a:r>
            <a:r>
              <a:rPr lang="en-GB" dirty="0"/>
              <a:t> transformations plotted against density for each of the four replicates at each sampling point. Samples colour-coded as shown in the figure. Note the variation among root-derived samples, particularly at 1% EWC, compared to the leaf-derived samples.</a:t>
            </a:r>
          </a:p>
        </p:txBody>
      </p:sp>
    </p:spTree>
    <p:extLst>
      <p:ext uri="{BB962C8B-B14F-4D97-AF65-F5344CB8AC3E}">
        <p14:creationId xmlns:p14="http://schemas.microsoft.com/office/powerpoint/2010/main" val="223495812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7B2C5F6D-84D2-4649-AFD4-E7093DFF1C36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752600" y="228600"/>
            <a:ext cx="6400800" cy="64008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0559820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7422</TotalTime>
  <Words>56</Words>
  <Application>Microsoft Macintosh PowerPoint</Application>
  <PresentationFormat>A4 Paper (210x297 mm)</PresentationFormat>
  <Paragraphs>1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6" baseType="lpstr">
      <vt:lpstr>Arial</vt:lpstr>
      <vt:lpstr>Calibri</vt:lpstr>
      <vt:lpstr>Calibri Light</vt:lpstr>
      <vt:lpstr>Office Theme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Ian Armstead [ipa]</dc:creator>
  <cp:lastModifiedBy>Microsoft Office User</cp:lastModifiedBy>
  <cp:revision>110</cp:revision>
  <dcterms:created xsi:type="dcterms:W3CDTF">2018-12-06T13:39:57Z</dcterms:created>
  <dcterms:modified xsi:type="dcterms:W3CDTF">2019-05-23T19:48:53Z</dcterms:modified>
</cp:coreProperties>
</file>